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59" r:id="rId2"/>
    <p:sldId id="282" r:id="rId3"/>
    <p:sldId id="270" r:id="rId4"/>
    <p:sldId id="284" r:id="rId5"/>
    <p:sldId id="278" r:id="rId6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319E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0294" autoAdjust="0"/>
    <p:restoredTop sz="94643"/>
  </p:normalViewPr>
  <p:slideViewPr>
    <p:cSldViewPr>
      <p:cViewPr>
        <p:scale>
          <a:sx n="66" d="100"/>
          <a:sy n="66" d="100"/>
        </p:scale>
        <p:origin x="-2196" y="64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AC8AFB8-72FF-43D2-B73D-1F0BA5F0B053}" type="datetimeFigureOut">
              <a:rPr lang="en-US" smtClean="0"/>
              <a:t>11/7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55AB334-8322-45D3-9E2D-B2B3FC9917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96642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55AB334-8322-45D3-9E2D-B2B3FC9917D8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864782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55AB334-8322-45D3-9E2D-B2B3FC9917D8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811151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C197B-234E-459B-811C-8FD1D3CF8280}" type="datetimeFigureOut">
              <a:rPr lang="en-US" smtClean="0"/>
              <a:t>11/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816A5-0547-4243-83DE-856E6FD2BC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28360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C197B-234E-459B-811C-8FD1D3CF8280}" type="datetimeFigureOut">
              <a:rPr lang="en-US" smtClean="0"/>
              <a:t>11/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816A5-0547-4243-83DE-856E6FD2BC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1604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C197B-234E-459B-811C-8FD1D3CF8280}" type="datetimeFigureOut">
              <a:rPr lang="en-US" smtClean="0"/>
              <a:t>11/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816A5-0547-4243-83DE-856E6FD2BC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88787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C197B-234E-459B-811C-8FD1D3CF8280}" type="datetimeFigureOut">
              <a:rPr lang="en-US" smtClean="0"/>
              <a:t>11/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816A5-0547-4243-83DE-856E6FD2BC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73341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C197B-234E-459B-811C-8FD1D3CF8280}" type="datetimeFigureOut">
              <a:rPr lang="en-US" smtClean="0"/>
              <a:t>11/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816A5-0547-4243-83DE-856E6FD2BC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48822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C197B-234E-459B-811C-8FD1D3CF8280}" type="datetimeFigureOut">
              <a:rPr lang="en-US" smtClean="0"/>
              <a:t>11/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816A5-0547-4243-83DE-856E6FD2BC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21769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C197B-234E-459B-811C-8FD1D3CF8280}" type="datetimeFigureOut">
              <a:rPr lang="en-US" smtClean="0"/>
              <a:t>11/7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816A5-0547-4243-83DE-856E6FD2BC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71458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C197B-234E-459B-811C-8FD1D3CF8280}" type="datetimeFigureOut">
              <a:rPr lang="en-US" smtClean="0"/>
              <a:t>11/7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816A5-0547-4243-83DE-856E6FD2BC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47660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C197B-234E-459B-811C-8FD1D3CF8280}" type="datetimeFigureOut">
              <a:rPr lang="en-US" smtClean="0"/>
              <a:t>11/7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816A5-0547-4243-83DE-856E6FD2BC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51411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C197B-234E-459B-811C-8FD1D3CF8280}" type="datetimeFigureOut">
              <a:rPr lang="en-US" smtClean="0"/>
              <a:t>11/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816A5-0547-4243-83DE-856E6FD2BC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02903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C197B-234E-459B-811C-8FD1D3CF8280}" type="datetimeFigureOut">
              <a:rPr lang="en-US" smtClean="0"/>
              <a:t>11/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816A5-0547-4243-83DE-856E6FD2BC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93659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6C197B-234E-459B-811C-8FD1D3CF8280}" type="datetimeFigureOut">
              <a:rPr lang="en-US" smtClean="0"/>
              <a:t>11/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8816A5-0547-4243-83DE-856E6FD2BC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81886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png"/><Relationship Id="rId5" Type="http://schemas.openxmlformats.org/officeDocument/2006/relationships/image" Target="../media/image13.png"/><Relationship Id="rId4" Type="http://schemas.openxmlformats.org/officeDocument/2006/relationships/image" Target="../media/image12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png"/><Relationship Id="rId3" Type="http://schemas.openxmlformats.org/officeDocument/2006/relationships/image" Target="../media/image15.png"/><Relationship Id="rId7" Type="http://schemas.openxmlformats.org/officeDocument/2006/relationships/image" Target="../media/image17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png"/><Relationship Id="rId5" Type="http://schemas.openxmlformats.org/officeDocument/2006/relationships/image" Target="../media/image16.png"/><Relationship Id="rId10" Type="http://schemas.openxmlformats.org/officeDocument/2006/relationships/image" Target="../media/image20.png"/><Relationship Id="rId4" Type="http://schemas.openxmlformats.org/officeDocument/2006/relationships/image" Target="../media/image10.png"/><Relationship Id="rId9" Type="http://schemas.openxmlformats.org/officeDocument/2006/relationships/image" Target="../media/image1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1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099" name="AutoShape 3"/>
          <p:cNvCxnSpPr>
            <a:cxnSpLocks noChangeShapeType="1"/>
          </p:cNvCxnSpPr>
          <p:nvPr/>
        </p:nvCxnSpPr>
        <p:spPr bwMode="auto">
          <a:xfrm>
            <a:off x="1096963" y="549446"/>
            <a:ext cx="274637" cy="0"/>
          </a:xfrm>
          <a:prstGeom prst="straightConnector1">
            <a:avLst/>
          </a:prstGeom>
          <a:noFill/>
          <a:ln w="12700">
            <a:solidFill>
              <a:srgbClr val="00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EEECE1"/>
                  </a:outerShdw>
                </a:effectLst>
              </a14:hiddenEffects>
            </a:ext>
          </a:extLst>
        </p:spPr>
      </p:cxnSp>
      <p:cxnSp>
        <p:nvCxnSpPr>
          <p:cNvPr id="4102" name="AutoShape 6"/>
          <p:cNvCxnSpPr>
            <a:cxnSpLocks noChangeShapeType="1"/>
          </p:cNvCxnSpPr>
          <p:nvPr/>
        </p:nvCxnSpPr>
        <p:spPr bwMode="auto">
          <a:xfrm>
            <a:off x="2259012" y="534503"/>
            <a:ext cx="274637" cy="0"/>
          </a:xfrm>
          <a:prstGeom prst="straightConnector1">
            <a:avLst/>
          </a:prstGeom>
          <a:noFill/>
          <a:ln w="12700" algn="ctr">
            <a:solidFill>
              <a:srgbClr val="00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EEECE1"/>
                  </a:outerShdw>
                </a:effectLst>
              </a14:hiddenEffects>
            </a:ext>
          </a:extLst>
        </p:spPr>
      </p:cxnSp>
      <p:cxnSp>
        <p:nvCxnSpPr>
          <p:cNvPr id="4111" name="AutoShape 15"/>
          <p:cNvCxnSpPr>
            <a:cxnSpLocks noChangeShapeType="1"/>
          </p:cNvCxnSpPr>
          <p:nvPr/>
        </p:nvCxnSpPr>
        <p:spPr bwMode="auto">
          <a:xfrm flipH="1">
            <a:off x="2546333" y="2492116"/>
            <a:ext cx="403225" cy="555625"/>
          </a:xfrm>
          <a:prstGeom prst="straightConnector1">
            <a:avLst/>
          </a:prstGeom>
          <a:noFill/>
          <a:ln w="12700">
            <a:solidFill>
              <a:srgbClr val="00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EEECE1"/>
                  </a:outerShdw>
                </a:effectLst>
              </a14:hiddenEffects>
            </a:ext>
          </a:extLst>
        </p:spPr>
      </p:cxnSp>
      <p:cxnSp>
        <p:nvCxnSpPr>
          <p:cNvPr id="4112" name="AutoShape 16"/>
          <p:cNvCxnSpPr>
            <a:cxnSpLocks noChangeShapeType="1"/>
          </p:cNvCxnSpPr>
          <p:nvPr/>
        </p:nvCxnSpPr>
        <p:spPr bwMode="auto">
          <a:xfrm>
            <a:off x="3875071" y="2492116"/>
            <a:ext cx="401637" cy="557212"/>
          </a:xfrm>
          <a:prstGeom prst="straightConnector1">
            <a:avLst/>
          </a:prstGeom>
          <a:noFill/>
          <a:ln w="12700">
            <a:solidFill>
              <a:srgbClr val="00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EEECE1"/>
                  </a:outerShdw>
                </a:effectLst>
              </a14:hiddenEffects>
            </a:ext>
          </a:extLst>
        </p:spPr>
      </p:cxnSp>
      <p:cxnSp>
        <p:nvCxnSpPr>
          <p:cNvPr id="4113" name="AutoShape 17"/>
          <p:cNvCxnSpPr>
            <a:cxnSpLocks noChangeShapeType="1"/>
          </p:cNvCxnSpPr>
          <p:nvPr/>
        </p:nvCxnSpPr>
        <p:spPr bwMode="auto">
          <a:xfrm flipH="1">
            <a:off x="4300694" y="3708400"/>
            <a:ext cx="206375" cy="271463"/>
          </a:xfrm>
          <a:prstGeom prst="straightConnector1">
            <a:avLst/>
          </a:prstGeom>
          <a:noFill/>
          <a:ln w="12700" algn="ctr">
            <a:solidFill>
              <a:srgbClr val="00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EEECE1"/>
                  </a:outerShdw>
                </a:effectLst>
              </a14:hiddenEffects>
            </a:ext>
          </a:extLst>
        </p:spPr>
      </p:cxnSp>
      <p:cxnSp>
        <p:nvCxnSpPr>
          <p:cNvPr id="4114" name="AutoShape 18"/>
          <p:cNvCxnSpPr>
            <a:cxnSpLocks noChangeShapeType="1"/>
          </p:cNvCxnSpPr>
          <p:nvPr/>
        </p:nvCxnSpPr>
        <p:spPr bwMode="auto">
          <a:xfrm>
            <a:off x="5143656" y="3713163"/>
            <a:ext cx="207963" cy="273050"/>
          </a:xfrm>
          <a:prstGeom prst="straightConnector1">
            <a:avLst/>
          </a:prstGeom>
          <a:noFill/>
          <a:ln w="12700" algn="ctr">
            <a:solidFill>
              <a:srgbClr val="00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EEECE1"/>
                  </a:outerShdw>
                </a:effectLst>
              </a14:hiddenEffects>
            </a:ext>
          </a:extLst>
        </p:spPr>
      </p:cxnSp>
      <p:cxnSp>
        <p:nvCxnSpPr>
          <p:cNvPr id="4115" name="AutoShape 19"/>
          <p:cNvCxnSpPr>
            <a:cxnSpLocks noChangeShapeType="1"/>
          </p:cNvCxnSpPr>
          <p:nvPr/>
        </p:nvCxnSpPr>
        <p:spPr bwMode="auto">
          <a:xfrm flipH="1">
            <a:off x="1598769" y="3733800"/>
            <a:ext cx="207963" cy="271462"/>
          </a:xfrm>
          <a:prstGeom prst="straightConnector1">
            <a:avLst/>
          </a:prstGeom>
          <a:noFill/>
          <a:ln w="12700" algn="ctr">
            <a:solidFill>
              <a:srgbClr val="00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EEECE1"/>
                  </a:outerShdw>
                </a:effectLst>
              </a14:hiddenEffects>
            </a:ext>
          </a:extLst>
        </p:spPr>
      </p:cxnSp>
      <p:cxnSp>
        <p:nvCxnSpPr>
          <p:cNvPr id="4116" name="AutoShape 20"/>
          <p:cNvCxnSpPr>
            <a:cxnSpLocks noChangeShapeType="1"/>
          </p:cNvCxnSpPr>
          <p:nvPr/>
        </p:nvCxnSpPr>
        <p:spPr bwMode="auto">
          <a:xfrm>
            <a:off x="2443319" y="3738562"/>
            <a:ext cx="206375" cy="273050"/>
          </a:xfrm>
          <a:prstGeom prst="straightConnector1">
            <a:avLst/>
          </a:prstGeom>
          <a:noFill/>
          <a:ln w="12700" algn="ctr">
            <a:solidFill>
              <a:srgbClr val="00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EEECE1"/>
                  </a:outerShdw>
                </a:effectLst>
              </a14:hiddenEffects>
            </a:ext>
          </a:extLst>
        </p:spPr>
      </p:cxnSp>
      <p:sp>
        <p:nvSpPr>
          <p:cNvPr id="2" name="Text Box 21"/>
          <p:cNvSpPr txBox="1">
            <a:spLocks noChangeArrowheads="1"/>
          </p:cNvSpPr>
          <p:nvPr/>
        </p:nvSpPr>
        <p:spPr bwMode="auto">
          <a:xfrm>
            <a:off x="52388" y="5257800"/>
            <a:ext cx="6815137" cy="12636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algn="in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EEECE1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lvl="0" algn="just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ort figure 1. Gating strategy used to assess the repertoire of Ly49 receptors expressed on CD8 T-cells. Dead cells were excluded using staining with FVS dye and cell morphology. Splenocytes were stained with a mixture of antibodies against TCRβ, CD8α and Ly49 receptors (A, D, H, G, F, and C/I) and gated on CD8 T-cells (TCRβ+CD8α+). Then the cells were divided stepwise according to expression of Ly49F or Ly49C/I, Ly49G, Ly49A and Ly49D+H. Each population frequency was determined and calculated. Plots are representative of 4 mice. 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1" name="AutoShape 14"/>
          <p:cNvCxnSpPr>
            <a:cxnSpLocks noChangeShapeType="1"/>
          </p:cNvCxnSpPr>
          <p:nvPr/>
        </p:nvCxnSpPr>
        <p:spPr bwMode="auto">
          <a:xfrm flipH="1">
            <a:off x="3771482" y="1036894"/>
            <a:ext cx="276896" cy="421483"/>
          </a:xfrm>
          <a:prstGeom prst="straightConnector1">
            <a:avLst/>
          </a:prstGeom>
          <a:noFill/>
          <a:ln w="12700" algn="ctr">
            <a:solidFill>
              <a:srgbClr val="00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EEECE1"/>
                  </a:outerShdw>
                </a:effectLst>
              </a14:hiddenEffects>
            </a:ext>
          </a:extLst>
        </p:spPr>
      </p:cxnSp>
      <p:cxnSp>
        <p:nvCxnSpPr>
          <p:cNvPr id="23" name="AutoShape 6"/>
          <p:cNvCxnSpPr>
            <a:cxnSpLocks noChangeShapeType="1"/>
          </p:cNvCxnSpPr>
          <p:nvPr/>
        </p:nvCxnSpPr>
        <p:spPr bwMode="auto">
          <a:xfrm>
            <a:off x="3419223" y="549446"/>
            <a:ext cx="274637" cy="0"/>
          </a:xfrm>
          <a:prstGeom prst="straightConnector1">
            <a:avLst/>
          </a:prstGeom>
          <a:noFill/>
          <a:ln w="12700" algn="ctr">
            <a:solidFill>
              <a:srgbClr val="00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EEECE1"/>
                  </a:outerShdw>
                </a:effectLst>
              </a14:hiddenEffects>
            </a:ext>
          </a:extLst>
        </p:spPr>
      </p:cxnSp>
      <p:pic>
        <p:nvPicPr>
          <p:cNvPr id="7170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0500" y="37613"/>
            <a:ext cx="914400" cy="97688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171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71600" y="30421"/>
            <a:ext cx="914400" cy="99126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172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14600" y="37613"/>
            <a:ext cx="914400" cy="99970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173" name="Picture 5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83000" y="55536"/>
            <a:ext cx="914400" cy="9878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175" name="Picture 7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51000" y="2610765"/>
            <a:ext cx="914400" cy="112303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176" name="Picture 8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76708" y="2621371"/>
            <a:ext cx="914400" cy="112925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178" name="Picture 10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19508" y="4011612"/>
            <a:ext cx="1828800" cy="110794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179" name="Picture 11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93800" y="4011612"/>
            <a:ext cx="1828800" cy="110409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48940" y="1488857"/>
            <a:ext cx="914400" cy="144058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8603088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Box 3"/>
          <p:cNvSpPr txBox="1">
            <a:spLocks noChangeArrowheads="1"/>
          </p:cNvSpPr>
          <p:nvPr/>
        </p:nvSpPr>
        <p:spPr bwMode="auto">
          <a:xfrm>
            <a:off x="80849" y="6858000"/>
            <a:ext cx="6624751" cy="1544637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 algn="in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EEECE1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lvl="0" algn="just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ort figure 2. Ly49+CD8 T-cells produce </a:t>
            </a:r>
            <a:r>
              <a:rPr lang="en-US" alt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FNγ</a:t>
            </a:r>
            <a:r>
              <a:rPr lang="en-US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response to the diverse array of viral peptides. A, the percentage of Ly49− memory phenotype CD8 T-cells and Ly49+CD8 T-cells among the total splenic CD8 T-cells at different time points after infection. The data is summarized from 2 independent experiments, each time point of each experiment has at least 4 mice. * – P(t) &lt; 0.05 comparing to </a:t>
            </a:r>
            <a:r>
              <a:rPr lang="en-US" sz="1000" dirty="0"/>
              <a:t>Ly49</a:t>
            </a:r>
            <a:r>
              <a:rPr lang="en-US" sz="1000" baseline="30000" dirty="0"/>
              <a:t>+</a:t>
            </a:r>
            <a:r>
              <a:rPr lang="en-US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8 </a:t>
            </a:r>
            <a:r>
              <a:rPr lang="en-US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-cells. # – P(t) &lt; 0.05 comparing to the same type of CD8 T-cells at the previous time point. @ – P(t) &lt; 0.05 comparing to the same type of CD8 T-cells from non-infected mice. B, splenocytes were stimulated with the indicated virus peptides in vitro and stained for </a:t>
            </a:r>
            <a:r>
              <a:rPr lang="en-US" alt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FNγ</a:t>
            </a:r>
            <a:r>
              <a:rPr lang="en-US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Representative pictures of </a:t>
            </a:r>
            <a:r>
              <a:rPr lang="en-US" alt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FNγ</a:t>
            </a:r>
            <a:r>
              <a:rPr lang="en-US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xpression among each type of CD8 T-cells at different time points are shown. Each time point of includes at least 4 mice</a:t>
            </a:r>
            <a:endParaRPr kumimoji="0" lang="en-US" altLang="en-US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9" name="Picture 7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789" y="-6014"/>
            <a:ext cx="388873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algn="in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EEECE1"/>
                  </a:outerShdw>
                </a:effectLst>
              </a14:hiddenEffects>
            </a:ext>
          </a:extLst>
        </p:spPr>
      </p:pic>
      <p:pic>
        <p:nvPicPr>
          <p:cNvPr id="60" name="Picture 8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0850" y="2667000"/>
            <a:ext cx="37875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algn="in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EEECE1"/>
                  </a:outerShdw>
                </a:effectLst>
              </a14:hiddenEffects>
            </a:ext>
          </a:extLst>
        </p:spPr>
      </p:pic>
      <p:pic>
        <p:nvPicPr>
          <p:cNvPr id="61" name="Picture 9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1676400" y="2857500"/>
            <a:ext cx="37945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algn="in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EEECE1"/>
                  </a:outerShdw>
                </a:effectLst>
              </a14:hiddenEffects>
            </a:ext>
          </a:extLst>
        </p:spPr>
      </p:pic>
      <p:pic>
        <p:nvPicPr>
          <p:cNvPr id="4102" name="Picture 6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392" y="289560"/>
            <a:ext cx="2241616" cy="23774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103" name="Picture 7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5212" y="2872273"/>
            <a:ext cx="6408644" cy="384048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90525689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5" name="Picture 7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43200" y="3163653"/>
            <a:ext cx="1920240" cy="139437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 Box 6"/>
          <p:cNvSpPr txBox="1">
            <a:spLocks noChangeArrowheads="1"/>
          </p:cNvSpPr>
          <p:nvPr/>
        </p:nvSpPr>
        <p:spPr bwMode="auto">
          <a:xfrm>
            <a:off x="96156" y="7010400"/>
            <a:ext cx="6688819" cy="1828800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 algn="in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EEECE1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lvl="0" algn="just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ort figure 3. CD8 T-cells from Ly49 KO show reduced up-regulation of KLRG1 during LCMV infection, but do not have major defects in cytokine production in response to major </a:t>
            </a:r>
            <a:r>
              <a:rPr lang="en-US" alt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mmunodominant</a:t>
            </a:r>
            <a:r>
              <a:rPr lang="en-US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iral peptides. A, surface phenotype and the relative amount </a:t>
            </a:r>
            <a:r>
              <a:rPr lang="en-US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LRG1</a:t>
            </a:r>
            <a:r>
              <a:rPr lang="en-US" altLang="en-US" sz="10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s among the splenic memory phenotype CD8 T-cells from intact or LCMV-infected (day 8) WT or Ly49 KO mice (day 8). Representative </a:t>
            </a:r>
            <a:r>
              <a:rPr lang="en-US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lots and the </a:t>
            </a:r>
            <a:r>
              <a:rPr lang="en-US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amount of </a:t>
            </a:r>
            <a:r>
              <a:rPr lang="en-US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LRG1</a:t>
            </a:r>
            <a:r>
              <a:rPr lang="en-US" altLang="en-US" sz="10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ells among the memory phenotype CD8 T-cells of LCMV-infected mice (day 8) are shown. The </a:t>
            </a:r>
            <a:r>
              <a:rPr lang="en-US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ta are summarized from 2 experiments with each group containing at least 4 mice. * – P(t) &lt; 0.05 comparing to WT mice. B, </a:t>
            </a:r>
            <a:r>
              <a:rPr lang="en-US" alt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FNγ</a:t>
            </a:r>
            <a:r>
              <a:rPr lang="en-US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TNFα expression by splenic CD8 T-cells from LCMV-infected (day 8) WT or Ly49 KO mice in response to the indicated peptides. Representative pictures and the relative amount of </a:t>
            </a:r>
            <a:r>
              <a:rPr lang="en-US" altLang="en-US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FNγ</a:t>
            </a:r>
            <a:r>
              <a:rPr lang="en-US" altLang="en-US" sz="10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 or TNFα</a:t>
            </a:r>
            <a:r>
              <a:rPr lang="en-US" altLang="en-US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D</a:t>
            </a:r>
            <a:r>
              <a:rPr lang="en-US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r>
              <a:rPr lang="en-US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# – P(t) &lt; 0.05 comparing to the same type of CD8 T-cells stimulated with gp33. The data is representative of 2 experiments, each experimental group has at least 4 mice. </a:t>
            </a:r>
            <a:endParaRPr lang="en-US" altLang="en-US" sz="100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1" name="Group 10"/>
          <p:cNvGrpSpPr/>
          <p:nvPr/>
        </p:nvGrpSpPr>
        <p:grpSpPr>
          <a:xfrm>
            <a:off x="76627" y="136506"/>
            <a:ext cx="2057400" cy="2357252"/>
            <a:chOff x="0" y="136506"/>
            <a:chExt cx="2057400" cy="2357252"/>
          </a:xfrm>
        </p:grpSpPr>
        <p:pic>
          <p:nvPicPr>
            <p:cNvPr id="15364" name="Picture 4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0" y="136506"/>
              <a:ext cx="388873" cy="4572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in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EEECE1"/>
                    </a:outerShdw>
                  </a:effectLst>
                </a14:hiddenEffects>
              </a:ext>
            </a:extLst>
          </p:spPr>
        </p:pic>
        <p:pic>
          <p:nvPicPr>
            <p:cNvPr id="8194" name="Picture 2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2501" y="443512"/>
              <a:ext cx="1964899" cy="205024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pic>
        <p:nvPicPr>
          <p:cNvPr id="17" name="Picture 9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52586" y="2819400"/>
            <a:ext cx="406176" cy="49050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algn="in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EEECE1"/>
                  </a:outerShdw>
                </a:effectLst>
              </a14:hiddenEffects>
            </a:ext>
          </a:extLst>
        </p:spPr>
      </p:pic>
      <p:pic>
        <p:nvPicPr>
          <p:cNvPr id="16" name="Picture 10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82022" y="2836050"/>
            <a:ext cx="394778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algn="in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EEECE1"/>
                  </a:outerShdw>
                </a:effectLst>
              </a14:hiddenEffects>
            </a:ext>
          </a:extLst>
        </p:spPr>
      </p:pic>
      <p:pic>
        <p:nvPicPr>
          <p:cNvPr id="12" name="Picture 5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14011" y="549772"/>
            <a:ext cx="1828800" cy="137339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6" name="Picture 8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60292" y="3163653"/>
            <a:ext cx="1920240" cy="13957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 Box 12"/>
          <p:cNvSpPr txBox="1">
            <a:spLocks noChangeArrowheads="1"/>
          </p:cNvSpPr>
          <p:nvPr/>
        </p:nvSpPr>
        <p:spPr bwMode="auto">
          <a:xfrm>
            <a:off x="5970944" y="3158033"/>
            <a:ext cx="509588" cy="405670"/>
          </a:xfrm>
          <a:prstGeom prst="rect">
            <a:avLst/>
          </a:prstGeom>
          <a:noFill/>
          <a:ln w="9525" algn="in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EEECE1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1" i="0" u="none" strike="noStrike" cap="none" normalizeH="0" baseline="0" dirty="0">
                <a:ln>
                  <a:noFill/>
                </a:ln>
                <a:solidFill>
                  <a:srgbClr val="0000C0"/>
                </a:solidFill>
                <a:effectLst/>
                <a:latin typeface="Calibri" pitchFamily="34" charset="0"/>
                <a:cs typeface="Arial" pitchFamily="34" charset="0"/>
              </a:rPr>
              <a:t>WT</a:t>
            </a:r>
          </a:p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1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alibri" pitchFamily="34" charset="0"/>
                <a:cs typeface="Arial" pitchFamily="34" charset="0"/>
              </a:rPr>
              <a:t>KO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69128" y="2508645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3978" y="2739456"/>
            <a:ext cx="2450592" cy="22427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58132425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Box 6"/>
          <p:cNvSpPr txBox="1">
            <a:spLocks noChangeArrowheads="1"/>
          </p:cNvSpPr>
          <p:nvPr/>
        </p:nvSpPr>
        <p:spPr bwMode="auto">
          <a:xfrm>
            <a:off x="0" y="8610600"/>
            <a:ext cx="6815137" cy="1219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algn="in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EEECE1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lvl="0" algn="just" fontAlgn="base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upport figure </a:t>
            </a:r>
            <a:r>
              <a:rPr kumimoji="0" lang="en-US" alt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4. </a:t>
            </a:r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Expression of Ly49 receptors </a:t>
            </a:r>
            <a:r>
              <a:rPr kumimoji="0" lang="en-US" altLang="en-US" sz="1000" b="0" i="0" u="none" strike="noStrike" cap="none" normalizeH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on </a:t>
            </a:r>
            <a:r>
              <a:rPr lang="en-US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ACS-purified </a:t>
            </a:r>
            <a:r>
              <a:rPr lang="en-US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y49</a:t>
            </a:r>
            <a:r>
              <a:rPr lang="en-US" altLang="en-US" sz="10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, naïve (B) and conventional memory phenotype (C) CD8 </a:t>
            </a:r>
            <a:r>
              <a:rPr lang="en-US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-cells stimulated at the indicated conditions </a:t>
            </a:r>
            <a:r>
              <a:rPr lang="en-US" alt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vitro. </a:t>
            </a:r>
            <a:r>
              <a:rPr lang="en-US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2 </a:t>
            </a:r>
            <a:r>
              <a:rPr lang="en-US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ours later  cells were collected and stained with a mixture of antibodies against the respective Ly49 receptors. Representative pictures of one out of six experiments are shown.</a:t>
            </a:r>
          </a:p>
        </p:txBody>
      </p:sp>
      <p:pic>
        <p:nvPicPr>
          <p:cNvPr id="45" name="Picture 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627" y="136506"/>
            <a:ext cx="388873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algn="in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EEECE1"/>
                  </a:outerShdw>
                </a:effectLst>
              </a14:hiddenEffects>
            </a:ext>
          </a:extLst>
        </p:spPr>
      </p:pic>
      <p:sp>
        <p:nvSpPr>
          <p:cNvPr id="46" name="TextBox 45"/>
          <p:cNvSpPr txBox="1"/>
          <p:nvPr/>
        </p:nvSpPr>
        <p:spPr>
          <a:xfrm>
            <a:off x="116213" y="4411492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pic>
        <p:nvPicPr>
          <p:cNvPr id="47" name="Picture 9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627" y="6358128"/>
            <a:ext cx="406176" cy="49050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algn="in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EEECE1"/>
                  </a:outerShdw>
                </a:effectLst>
              </a14:hiddenEffects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4800" y="19050"/>
            <a:ext cx="5029200" cy="852124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86400259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Box 3"/>
          <p:cNvSpPr txBox="1">
            <a:spLocks noChangeArrowheads="1"/>
          </p:cNvSpPr>
          <p:nvPr/>
        </p:nvSpPr>
        <p:spPr bwMode="auto">
          <a:xfrm>
            <a:off x="0" y="0"/>
            <a:ext cx="6819900" cy="30019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algn="in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EEECE1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lvl="0" algn="just" fontAlgn="base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upport table 1. The amount of </a:t>
            </a:r>
            <a:r>
              <a:rPr lang="en-US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y49</a:t>
            </a:r>
            <a:r>
              <a:rPr lang="en-US" altLang="en-US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D8 T-cells stimulated at different conditions </a:t>
            </a:r>
            <a:r>
              <a:rPr kumimoji="0" lang="en-US" altLang="en-US" sz="10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in vitro </a:t>
            </a:r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nd expressing the particular combination of Ly49 receptors. Mean value ± SEM are presented. Data collected from 6 separate experiments.</a:t>
            </a:r>
            <a:endParaRPr kumimoji="0" lang="en-US" altLang="en-US" sz="1000" b="0" i="0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* – P</a:t>
            </a:r>
            <a:r>
              <a:rPr kumimoji="0" lang="en-US" altLang="en-US" sz="1000" b="0" i="0" u="none" strike="noStrike" cap="none" normalizeH="0" baseline="-2500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(t)</a:t>
            </a:r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&lt; 0.05 comparing to the IL2-cultured cells.</a:t>
            </a:r>
          </a:p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# – P</a:t>
            </a:r>
            <a:r>
              <a:rPr kumimoji="0" lang="en-US" altLang="en-US" sz="1000" b="0" i="0" u="none" strike="noStrike" cap="none" normalizeH="0" baseline="-2500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(t)</a:t>
            </a:r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&lt; 0.05 comparing to the IL15-cultured cells.</a:t>
            </a:r>
          </a:p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@ – P</a:t>
            </a:r>
            <a:r>
              <a:rPr kumimoji="0" lang="en-US" altLang="en-US" sz="1000" b="0" i="0" u="none" strike="noStrike" cap="none" normalizeH="0" baseline="-2500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(t)</a:t>
            </a:r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&lt; 0.05 comparing to the cells stimulated with anti-CD3/anti-CD28 and IL15.</a:t>
            </a:r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21724316"/>
              </p:ext>
            </p:extLst>
          </p:nvPr>
        </p:nvGraphicFramePr>
        <p:xfrm>
          <a:off x="0" y="1143000"/>
          <a:ext cx="6858000" cy="687070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838200"/>
                <a:gridCol w="914400"/>
                <a:gridCol w="914400"/>
                <a:gridCol w="1036796"/>
                <a:gridCol w="1102201"/>
                <a:gridCol w="1102201"/>
                <a:gridCol w="949802"/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50" b="0" u="none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y49 receptors</a:t>
                      </a:r>
                      <a:endParaRPr lang="en-US" sz="1050" b="0" u="none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="0" u="none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2 50 U/ml</a:t>
                      </a:r>
                      <a:endParaRPr lang="en-US" sz="1050" b="0" u="none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="0" u="none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15 50 ng/ml</a:t>
                      </a:r>
                      <a:endParaRPr lang="en-US" sz="1050" b="0" u="none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l-GR" sz="1050" b="0" u="none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</a:t>
                      </a:r>
                      <a:r>
                        <a:rPr lang="en-US" sz="1050" b="0" u="none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3</a:t>
                      </a:r>
                    </a:p>
                    <a:p>
                      <a:pPr algn="ctr"/>
                      <a:r>
                        <a:rPr lang="el-GR" sz="1050" b="0" u="none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</a:t>
                      </a:r>
                      <a:r>
                        <a:rPr lang="en-US" sz="1050" b="0" u="none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28</a:t>
                      </a:r>
                    </a:p>
                  </a:txBody>
                  <a:tcPr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l-GR" sz="1050" b="0" u="none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</a:t>
                      </a:r>
                      <a:r>
                        <a:rPr lang="en-US" sz="1050" b="0" u="none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3</a:t>
                      </a:r>
                    </a:p>
                    <a:p>
                      <a:pPr algn="ctr"/>
                      <a:r>
                        <a:rPr lang="el-GR" sz="1050" b="0" u="none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</a:t>
                      </a:r>
                      <a:r>
                        <a:rPr lang="en-US" sz="1050" b="0" u="none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28</a:t>
                      </a:r>
                    </a:p>
                    <a:p>
                      <a:pPr algn="ctr"/>
                      <a:r>
                        <a:rPr lang="en-US" sz="1050" b="0" u="none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2</a:t>
                      </a:r>
                      <a:endParaRPr lang="en-US" sz="1050" b="0" u="none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l-GR" sz="1050" b="0" u="none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</a:t>
                      </a:r>
                      <a:r>
                        <a:rPr lang="en-US" sz="1050" b="0" u="none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3</a:t>
                      </a:r>
                    </a:p>
                    <a:p>
                      <a:pPr algn="ctr"/>
                      <a:r>
                        <a:rPr lang="el-GR" sz="1050" b="0" u="none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</a:t>
                      </a:r>
                      <a:r>
                        <a:rPr lang="en-US" sz="1050" b="0" u="none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28</a:t>
                      </a:r>
                    </a:p>
                    <a:p>
                      <a:pPr algn="ctr"/>
                      <a:r>
                        <a:rPr lang="en-US" sz="1050" b="0" u="none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15</a:t>
                      </a:r>
                    </a:p>
                  </a:txBody>
                  <a:tcPr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l-GR" sz="1050" b="0" u="none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</a:t>
                      </a:r>
                      <a:r>
                        <a:rPr lang="en-US" sz="1050" b="0" u="none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3</a:t>
                      </a:r>
                    </a:p>
                    <a:p>
                      <a:pPr algn="ctr"/>
                      <a:r>
                        <a:rPr lang="el-GR" sz="1050" b="0" u="none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</a:t>
                      </a:r>
                      <a:r>
                        <a:rPr lang="en-US" sz="1050" b="0" u="none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28</a:t>
                      </a:r>
                    </a:p>
                    <a:p>
                      <a:pPr algn="ctr"/>
                      <a:r>
                        <a:rPr lang="en-US" sz="1050" b="0" u="none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2+L15</a:t>
                      </a:r>
                    </a:p>
                  </a:txBody>
                  <a:tcPr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50" b="0" u="none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r>
                        <a:rPr lang="en-US" sz="1050" b="0" u="none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Ly49</a:t>
                      </a:r>
                      <a:endParaRPr lang="en-US" sz="1050" b="0" u="none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92 ± 3.26</a:t>
                      </a:r>
                      <a:endParaRPr lang="en-US" sz="105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76 ± 0.95</a:t>
                      </a:r>
                      <a:endParaRPr lang="en-US" sz="105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.40 ± 2.43</a:t>
                      </a:r>
                    </a:p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#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13" marR="3213" marT="3213" marB="0"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.29 ± 3.58</a:t>
                      </a:r>
                    </a:p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#</a:t>
                      </a:r>
                      <a:endParaRPr lang="en-US" sz="105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.68 ± 2.59</a:t>
                      </a:r>
                    </a:p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#</a:t>
                      </a:r>
                      <a:endParaRPr lang="en-US" sz="105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.44 ± 4.83</a:t>
                      </a:r>
                    </a:p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#</a:t>
                      </a:r>
                      <a:endParaRPr lang="en-US" sz="1050" b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50" b="0" u="none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endParaRPr lang="en-US" sz="1050" b="0" u="none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2 ± 0.62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13" marR="3213" marT="3213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37 ± 0.46</a:t>
                      </a:r>
                      <a:endParaRPr lang="en-US" sz="105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11 ± 0.76</a:t>
                      </a:r>
                      <a:endParaRPr lang="en-US" sz="105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13" marR="3213" marT="3213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61 ± 0.37</a:t>
                      </a:r>
                      <a:endParaRPr lang="en-US" sz="105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89 ± 0.47</a:t>
                      </a:r>
                      <a:endParaRPr lang="en-US" sz="105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45 ± 0.67</a:t>
                      </a:r>
                      <a:endParaRPr lang="en-US" sz="105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50" b="0" u="none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</a:t>
                      </a:r>
                      <a:endParaRPr lang="en-US" sz="1050" b="0" u="none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0 ± 0.46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13" marR="3213" marT="3213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7 ± 0.10</a:t>
                      </a:r>
                      <a:endParaRPr lang="en-US" sz="105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25 ± 0.93</a:t>
                      </a:r>
                    </a:p>
                    <a:p>
                      <a:pPr algn="ctr" fontAlgn="ctr"/>
                      <a:r>
                        <a:rPr lang="en-US" sz="105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#</a:t>
                      </a:r>
                      <a:endParaRPr lang="en-US" sz="105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13" marR="3213" marT="32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93 ± 1.80</a:t>
                      </a:r>
                    </a:p>
                    <a:p>
                      <a:pPr algn="ctr" fontAlgn="ctr"/>
                      <a:r>
                        <a:rPr lang="en-US" sz="105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#@</a:t>
                      </a:r>
                      <a:endParaRPr lang="en-US" sz="105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57 ± 0.79</a:t>
                      </a:r>
                    </a:p>
                    <a:p>
                      <a:pPr algn="ctr" fontAlgn="ctr"/>
                      <a:r>
                        <a:rPr lang="en-US" sz="105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#</a:t>
                      </a:r>
                      <a:endParaRPr lang="en-US" sz="105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05 ± 1.60</a:t>
                      </a:r>
                    </a:p>
                    <a:p>
                      <a:pPr algn="ctr" fontAlgn="ctr"/>
                      <a:r>
                        <a:rPr lang="en-US" sz="105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#@</a:t>
                      </a:r>
                      <a:endParaRPr lang="en-US" sz="105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50" b="0" u="none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1050" b="0" u="none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04 ± 3.22</a:t>
                      </a:r>
                    </a:p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@#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13" marR="3213" marT="32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.68 ± 3.29</a:t>
                      </a:r>
                    </a:p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@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13" marR="3213" marT="32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10 ± 2.13</a:t>
                      </a:r>
                    </a:p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@#</a:t>
                      </a:r>
                    </a:p>
                  </a:txBody>
                  <a:tcPr marL="3213" marR="3213" marT="32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16 ± 3.93</a:t>
                      </a:r>
                    </a:p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@#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13" marR="3213" marT="32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.66  ± 3.97</a:t>
                      </a:r>
                    </a:p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13" marR="3213" marT="32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.21 ± 4.47</a:t>
                      </a:r>
                    </a:p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@#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13" marR="3213" marT="3213" marB="0" anchor="ctr"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50" b="0" u="none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H</a:t>
                      </a:r>
                      <a:endParaRPr lang="en-US" sz="1050" b="0" u="none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4 ± 0.19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13" marR="3213" marT="32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8 ± 0.10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13" marR="3213" marT="32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96 ± 1.96</a:t>
                      </a:r>
                    </a:p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#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13" marR="3213" marT="32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54 ± 1.56</a:t>
                      </a:r>
                    </a:p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#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13" marR="3213" marT="32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65 ± 0.70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13" marR="3213" marT="32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57 ± 2.72</a:t>
                      </a:r>
                    </a:p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13" marR="3213" marT="3213" marB="0" anchor="ctr"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50" b="0" u="none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</a:t>
                      </a:r>
                      <a:endParaRPr lang="en-US" sz="1050" b="0" u="none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15 ± 1.63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13" marR="3213" marT="32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41 ± 0.39</a:t>
                      </a:r>
                    </a:p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13" marR="3213" marT="32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97 ± 1.22</a:t>
                      </a:r>
                    </a:p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13" marR="3213" marT="32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07 ± 1.19</a:t>
                      </a:r>
                    </a:p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13" marR="3213" marT="32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59 ± 0.75</a:t>
                      </a:r>
                    </a:p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13" marR="3213" marT="32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37 ± 1.03</a:t>
                      </a:r>
                    </a:p>
                    <a:p>
                      <a:pPr algn="ctr" fontAlgn="ctr"/>
                      <a:r>
                        <a:rPr lang="en-US" sz="105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endParaRPr lang="en-US" sz="105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50" b="0" u="none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G</a:t>
                      </a:r>
                      <a:endParaRPr lang="en-US" sz="1050" b="0" u="none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.28 ± 2.57</a:t>
                      </a:r>
                    </a:p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13" marR="3213" marT="32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.20 ± 0.67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13" marR="3213" marT="32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56 ± 0.90</a:t>
                      </a:r>
                    </a:p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#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13" marR="3213" marT="32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05 ± 0.69</a:t>
                      </a:r>
                    </a:p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13" marR="3213" marT="32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24 ± 0.76</a:t>
                      </a:r>
                    </a:p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13" marR="3213" marT="32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28 ± 2.80</a:t>
                      </a:r>
                    </a:p>
                    <a:p>
                      <a:pPr algn="ctr" fontAlgn="ctr"/>
                      <a:r>
                        <a:rPr lang="en-US" sz="105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</a:t>
                      </a:r>
                      <a:endParaRPr lang="en-US" sz="105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50" b="0" u="none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</a:t>
                      </a:r>
                      <a:endParaRPr lang="en-US" sz="1050" b="0" u="none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42 ± 0.31</a:t>
                      </a:r>
                    </a:p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13" marR="3213" marT="32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0 ± 0.24</a:t>
                      </a:r>
                    </a:p>
                  </a:txBody>
                  <a:tcPr marL="3213" marR="3213" marT="32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62 ± 0.57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13" marR="3213" marT="32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48 ± 0.65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13" marR="3213" marT="32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88 ± 0.43</a:t>
                      </a:r>
                    </a:p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13" marR="3213" marT="3213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26 ± 0.90</a:t>
                      </a:r>
                      <a:endParaRPr lang="en-US" sz="105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50" b="0" u="none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H</a:t>
                      </a:r>
                      <a:endParaRPr lang="en-US" sz="1050" b="0" u="none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6 ± 0.17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13" marR="3213" marT="32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7 ± 0.05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13" marR="3213" marT="32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6 ± 0.12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13" marR="3213" marT="32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5 ± 0.39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13" marR="3213" marT="32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8 ± 0.11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13" marR="3213" marT="32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0 ± 0.47</a:t>
                      </a:r>
                    </a:p>
                    <a:p>
                      <a:pPr algn="ctr" fontAlgn="ctr"/>
                      <a:r>
                        <a:rPr lang="en-US" sz="105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</a:t>
                      </a:r>
                      <a:endParaRPr lang="en-US" sz="105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50" b="0" u="none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DH</a:t>
                      </a:r>
                      <a:endParaRPr lang="en-US" sz="1050" b="0" u="none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0 ± 0.07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13" marR="3213" marT="32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84 ± 0.34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13" marR="3213" marT="32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13 ± 1.40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13" marR="3213" marT="32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02 ± 0.76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13" marR="3213" marT="32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84 ± 0.67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13" marR="3213" marT="3213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0 ± 0.66</a:t>
                      </a:r>
                      <a:endParaRPr lang="en-US" sz="105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50" b="0" u="none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DH</a:t>
                      </a:r>
                      <a:endParaRPr lang="en-US" sz="1050" b="0" u="none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4 ± 0.13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13" marR="3213" marT="32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6 ± 0.05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13" marR="3213" marT="32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2 ± 0.48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13" marR="3213" marT="32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0 ± 0.60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13" marR="3213" marT="32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4 ± 0.48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13" marR="3213" marT="32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17 ± 1.33</a:t>
                      </a:r>
                    </a:p>
                    <a:p>
                      <a:pPr algn="ctr" fontAlgn="ctr"/>
                      <a:r>
                        <a:rPr lang="en-US" sz="105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#</a:t>
                      </a:r>
                      <a:endParaRPr lang="en-US" sz="105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50" b="0" u="none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GA</a:t>
                      </a:r>
                      <a:endParaRPr lang="en-US" sz="1050" b="0" u="none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.67 ± 3.07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13" marR="3213" marT="32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98 ± 1.11</a:t>
                      </a:r>
                    </a:p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13" marR="3213" marT="32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04 ± 1.51</a:t>
                      </a:r>
                    </a:p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13" marR="3213" marT="32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32 ± 2.52</a:t>
                      </a:r>
                    </a:p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13" marR="3213" marT="32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83 ± 1.88</a:t>
                      </a:r>
                    </a:p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13" marR="3213" marT="32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80 ± 2.17</a:t>
                      </a:r>
                    </a:p>
                    <a:p>
                      <a:pPr algn="ctr" fontAlgn="ctr"/>
                      <a:r>
                        <a:rPr lang="en-US" sz="105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endParaRPr lang="en-US" sz="105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50" b="0" u="none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DH</a:t>
                      </a:r>
                      <a:endParaRPr lang="en-US" sz="1050" b="0" u="none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2 ± 0.21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13" marR="3213" marT="32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4 ± 0.07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13" marR="3213" marT="32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4 ± 0.12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13" marR="3213" marT="32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7 ± 0.35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13" marR="3213" marT="32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4 ± 0.16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13" marR="3213" marT="32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7 ± 0.45</a:t>
                      </a:r>
                    </a:p>
                    <a:p>
                      <a:pPr algn="ctr" fontAlgn="ctr"/>
                      <a:r>
                        <a:rPr lang="en-US" sz="105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</a:t>
                      </a:r>
                      <a:endParaRPr lang="en-US" sz="105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50" b="0" u="none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DH</a:t>
                      </a:r>
                      <a:endParaRPr lang="en-US" sz="1050" b="0" u="none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5 ± 0.44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13" marR="3213" marT="32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4 ± 0.07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13" marR="3213" marT="32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2 ± 0.51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13" marR="3213" marT="32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8 ± 0.26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13" marR="3213" marT="32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3 ± 0.26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13" marR="3213" marT="3213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1 ± 0.45</a:t>
                      </a:r>
                      <a:endParaRPr lang="en-US" sz="105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50" b="0" u="none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GDH</a:t>
                      </a:r>
                      <a:endParaRPr lang="en-US" sz="1050" b="0" u="none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6 ± 0.40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13" marR="3213" marT="32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2 ± 0.27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13" marR="3213" marT="32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86 ± 0.42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13" marR="3213" marT="32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64 ± 0.72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13" marR="3213" marT="32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34 ± 0.31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13" marR="3213" marT="3213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66 ± 0.72</a:t>
                      </a:r>
                      <a:endParaRPr lang="en-US" sz="105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50" b="0" u="none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GADH</a:t>
                      </a:r>
                      <a:endParaRPr lang="en-US" sz="1050" b="0" u="none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93 ± 1.93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13" marR="3213" marT="3213" marB="0" anchor="ctr"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 ± 0.39</a:t>
                      </a:r>
                    </a:p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13" marR="3213" marT="3213" marB="0" anchor="ctr"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85 ± 0.48</a:t>
                      </a:r>
                    </a:p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13" marR="3213" marT="3213" marB="0" anchor="ctr"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38 ± 0.73</a:t>
                      </a:r>
                    </a:p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13" marR="3213" marT="3213" marB="0" anchor="ctr"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34 ± 0.47</a:t>
                      </a:r>
                    </a:p>
                    <a:p>
                      <a:pPr algn="ctr" fontAlgn="ctr"/>
                      <a:r>
                        <a:rPr lang="en-US" sz="10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13" marR="3213" marT="3213" marB="0" anchor="ctr"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84 ± 1.07</a:t>
                      </a:r>
                    </a:p>
                    <a:p>
                      <a:pPr algn="ctr" fontAlgn="ctr"/>
                      <a:r>
                        <a:rPr lang="en-US" sz="1050" b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endParaRPr lang="en-US" sz="105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4036605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910</TotalTime>
  <Words>991</Words>
  <Application>Microsoft Office PowerPoint</Application>
  <PresentationFormat>On-screen Show (4:3)</PresentationFormat>
  <Paragraphs>182</Paragraphs>
  <Slides>5</Slides>
  <Notes>2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enovo</dc:creator>
  <cp:lastModifiedBy>lenovo</cp:lastModifiedBy>
  <cp:revision>284</cp:revision>
  <dcterms:created xsi:type="dcterms:W3CDTF">2020-07-20T08:00:31Z</dcterms:created>
  <dcterms:modified xsi:type="dcterms:W3CDTF">2020-11-07T13:44:47Z</dcterms:modified>
</cp:coreProperties>
</file>